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1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CE466D-5F1A-4841-91C7-1A2D8DA0AC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300D77-6B18-47EE-86D6-45767CCC22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th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1F9360-EA61-4039-85B7-8364E09E7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269875-59E1-4EBA-8D0B-7523975CA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4E47D0-E5E7-478A-9DE0-575445645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09378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B977DB-BB2A-4DF5-938F-D7D7146C92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42EE60-5E62-4E29-B48B-5B8BCEEA27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92EAF0-C9BD-44CD-91D9-E49DB1A9B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0380EA-AA7C-4345-8100-8586068043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947E49-CCC4-4EFE-9A3D-829DAA6694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682461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9AF797-F98F-4EC6-8183-D1C8612154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DEA867-BB17-441F-B16E-B8BEA22AC2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A3F7C7-EC63-4EFF-94BD-87FB2A816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4A46D9-B3F1-4D4F-B925-F02146A054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993EE9-6905-4C22-847C-670A4849C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84831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34D79C-F15D-4979-B6F8-C8730A35EE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D89681-B578-41C0-B22C-A94CF859AF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FB09E6-57C5-42A7-A887-54F2761E4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F7F80E-CDDF-4A1E-99FF-1F4EC35F9A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2EAF1B-85BA-42B1-8F86-312896D1DB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856342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18FC1C-930B-4133-9F24-BA6A0B427B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05FE65-B751-48A9-A026-7239E78C00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56ACDA-80DB-4F32-81AE-58DC64271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1A9797-89F6-4836-87A6-D6E857215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1AA25C-8670-4AD7-AF88-E5BA0CCA3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759803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6B8AA7-F2D7-4A9E-95E2-95F2BC583C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C4C60E-AA99-43B3-88CF-8F4E0F528A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764338-1285-4429-93B4-CC6731ED04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568991-90FB-4A9D-97AD-5E6749739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500179-591F-4522-979B-57E682EDA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896B14-8160-44D7-924D-2C689A7F1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096277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99FF0-F52D-44CB-AE8F-4F6E29F2B0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F28A15-2B3D-41BB-9B56-82FED1A353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708B11-D45E-4980-B299-30E0D9C9FE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8D9D28-F0FB-42F5-9981-B316957577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405A9E-C5B6-4114-944E-1A5762D0C5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7BC9357-3315-4882-8C44-1E9001739D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D70AD1-1D01-40F8-8DF1-A618650DE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8DB838-FFFA-4A90-B3A3-16F22C6F9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510828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F5AC27-7E0B-44D0-8F0C-94D1EE5C57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1BFE96B-C346-49C7-8CAC-C81A05289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6B0C57-8E43-4148-B000-B7A3BC42B5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0EC3E0-03FA-4A9F-B324-A23EFEA748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434062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9076B1D-D372-4304-91BF-0A0FB08D7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204A20D-4688-4F88-AD5E-A02F63DFD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70331B-B9C3-4EEE-93E7-55AB9C635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797994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6BD54B-5F5A-40BE-91D7-988EA3BD31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44B5F8-18DF-41A7-9EF3-D11F25BD95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52A586-7C29-4F7A-87A8-4950139106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757483-17BD-4DC7-95F6-C8526628A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2E9A58-0975-4A07-A961-757EC0833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B84A9D-BBFA-4544-B356-26DFF68F0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85329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7BB0FC-96FA-41D2-8730-BABE88C5A4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72135D4-D229-44F2-9EB6-D4265F3FAE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8B16EE-2DBB-472F-AEC6-2217E3B645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207756-F017-42A7-BD55-8391C1911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2076E0-95D7-4BEA-A59F-2FFACD157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947D62-163B-46A2-A91B-5DFD5BF1D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224663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514E644-02E0-4858-8324-C795D51A96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52C98B-FA3D-4499-B1AE-BADB12DEAE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66B27F-D389-48D6-B3D0-D7CE3F4C3A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FCEA4-8041-420A-BE1A-31E090C1EF83}" type="datetimeFigureOut">
              <a:rPr lang="th-TH" smtClean="0"/>
              <a:t>28/02/63</a:t>
            </a:fld>
            <a:endParaRPr lang="th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B53594-C894-4730-94AA-71DA12D2D5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FEE6E7-095D-407A-9EF3-F08743A583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0AD9E9-E013-4EE4-A5A8-9F665B51AC1E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045121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4">
            <a:extLst>
              <a:ext uri="{FF2B5EF4-FFF2-40B4-BE49-F238E27FC236}">
                <a16:creationId xmlns:a16="http://schemas.microsoft.com/office/drawing/2014/main" id="{A6161FDC-F1E5-47DB-B1CB-DDFF43E8BC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5177" y="1109095"/>
            <a:ext cx="749617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0" hangingPunct="0"/>
            <a:r>
              <a:rPr lang="en-US" sz="2000" b="1" dirty="0">
                <a:latin typeface="+mj-lt"/>
                <a:cs typeface="BrowalliaUPC" pitchFamily="34" charset="-34"/>
              </a:rPr>
              <a:t>       1                               2                                  3                               4</a:t>
            </a:r>
          </a:p>
        </p:txBody>
      </p:sp>
      <p:pic>
        <p:nvPicPr>
          <p:cNvPr id="8" name="Picture 2">
            <a:extLst>
              <a:ext uri="{FF2B5EF4-FFF2-40B4-BE49-F238E27FC236}">
                <a16:creationId xmlns:a16="http://schemas.microsoft.com/office/drawing/2014/main" id="{5EFAD3A1-EB87-408A-8871-B62239ECBFA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grayscl/>
            <a:lum bright="10000" contrast="10000"/>
          </a:blip>
          <a:srcRect/>
          <a:stretch>
            <a:fillRect/>
          </a:stretch>
        </p:blipFill>
        <p:spPr bwMode="auto">
          <a:xfrm>
            <a:off x="2118360" y="1533311"/>
            <a:ext cx="7955280" cy="31597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0E9C0F39-0BF4-4CAB-BBEC-921FFCF6A271}"/>
              </a:ext>
            </a:extLst>
          </p:cNvPr>
          <p:cNvCxnSpPr/>
          <p:nvPr/>
        </p:nvCxnSpPr>
        <p:spPr>
          <a:xfrm rot="5400000">
            <a:off x="4792748" y="2237875"/>
            <a:ext cx="228600" cy="1524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" name="TextBox 11">
            <a:extLst>
              <a:ext uri="{FF2B5EF4-FFF2-40B4-BE49-F238E27FC236}">
                <a16:creationId xmlns:a16="http://schemas.microsoft.com/office/drawing/2014/main" id="{84EB0320-85FB-4E06-A787-66C1E34845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9512" y="1808543"/>
            <a:ext cx="1749425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0" hangingPunct="0"/>
            <a:r>
              <a:rPr lang="en-US" sz="2000" b="1" dirty="0">
                <a:solidFill>
                  <a:srgbClr val="C00000"/>
                </a:solidFill>
                <a:latin typeface="BrowalliaUPC" pitchFamily="34" charset="-34"/>
                <a:cs typeface="BrowalliaUPC" pitchFamily="34" charset="-34"/>
              </a:rPr>
              <a:t>Fibroblast-like cells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40FCB436-BC56-43F1-B87A-1CF12E3A169B}"/>
              </a:ext>
            </a:extLst>
          </p:cNvPr>
          <p:cNvCxnSpPr/>
          <p:nvPr/>
        </p:nvCxnSpPr>
        <p:spPr>
          <a:xfrm rot="5400000">
            <a:off x="4694940" y="4031419"/>
            <a:ext cx="228600" cy="1524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TextBox 13">
            <a:extLst>
              <a:ext uri="{FF2B5EF4-FFF2-40B4-BE49-F238E27FC236}">
                <a16:creationId xmlns:a16="http://schemas.microsoft.com/office/drawing/2014/main" id="{023DA60C-AB82-43A8-A933-A7AA60AB75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88528" y="3459919"/>
            <a:ext cx="1089025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0" hangingPunct="0"/>
            <a:r>
              <a:rPr lang="en-US" sz="2000" b="1" dirty="0">
                <a:latin typeface="BrowalliaUPC" pitchFamily="34" charset="-34"/>
                <a:cs typeface="BrowalliaUPC" pitchFamily="34" charset="-34"/>
              </a:rPr>
              <a:t>Epithelium 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97DD27E6-AC74-4A5B-8FC8-6DFC099E586E}"/>
              </a:ext>
            </a:extLst>
          </p:cNvPr>
          <p:cNvCxnSpPr/>
          <p:nvPr/>
        </p:nvCxnSpPr>
        <p:spPr>
          <a:xfrm rot="10800000" flipV="1">
            <a:off x="6466305" y="1666376"/>
            <a:ext cx="228600" cy="150813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600D325F-06D8-4EF5-8B64-A324AED218BE}"/>
              </a:ext>
            </a:extLst>
          </p:cNvPr>
          <p:cNvCxnSpPr/>
          <p:nvPr/>
        </p:nvCxnSpPr>
        <p:spPr>
          <a:xfrm rot="10800000" flipV="1">
            <a:off x="2983856" y="2007575"/>
            <a:ext cx="228600" cy="1524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407D8058-7881-4E13-A41F-044454FB507F}"/>
              </a:ext>
            </a:extLst>
          </p:cNvPr>
          <p:cNvCxnSpPr/>
          <p:nvPr/>
        </p:nvCxnSpPr>
        <p:spPr>
          <a:xfrm rot="5400000">
            <a:off x="6904740" y="3574219"/>
            <a:ext cx="228600" cy="1524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1A3F4CFA-2327-41A1-9465-4F630400D0CF}"/>
              </a:ext>
            </a:extLst>
          </p:cNvPr>
          <p:cNvCxnSpPr/>
          <p:nvPr/>
        </p:nvCxnSpPr>
        <p:spPr>
          <a:xfrm rot="5400000">
            <a:off x="9343140" y="3726619"/>
            <a:ext cx="228600" cy="1524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C6FC2174-E159-49DB-BCD6-71BE812A73AF}"/>
              </a:ext>
            </a:extLst>
          </p:cNvPr>
          <p:cNvCxnSpPr/>
          <p:nvPr/>
        </p:nvCxnSpPr>
        <p:spPr>
          <a:xfrm rot="5400000">
            <a:off x="8804052" y="1751107"/>
            <a:ext cx="228600" cy="1524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grpSp>
        <p:nvGrpSpPr>
          <p:cNvPr id="18" name="Group 16">
            <a:extLst>
              <a:ext uri="{FF2B5EF4-FFF2-40B4-BE49-F238E27FC236}">
                <a16:creationId xmlns:a16="http://schemas.microsoft.com/office/drawing/2014/main" id="{D56291BB-D699-43DD-8B1B-0F6DA6B2ACD9}"/>
              </a:ext>
            </a:extLst>
          </p:cNvPr>
          <p:cNvGrpSpPr>
            <a:grpSpLocks/>
          </p:cNvGrpSpPr>
          <p:nvPr/>
        </p:nvGrpSpPr>
        <p:grpSpPr bwMode="auto">
          <a:xfrm>
            <a:off x="7461953" y="4317169"/>
            <a:ext cx="715962" cy="392113"/>
            <a:chOff x="6021674" y="5791436"/>
            <a:chExt cx="643125" cy="338554"/>
          </a:xfrm>
        </p:grpSpPr>
        <p:sp>
          <p:nvSpPr>
            <p:cNvPr id="19" name="TextBox 23">
              <a:extLst>
                <a:ext uri="{FF2B5EF4-FFF2-40B4-BE49-F238E27FC236}">
                  <a16:creationId xmlns:a16="http://schemas.microsoft.com/office/drawing/2014/main" id="{2A46FD5B-FD22-4D7E-B4CC-8A9A59A9C5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674" y="5791436"/>
              <a:ext cx="64312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600" b="1">
                  <a:latin typeface="Browallia New" pitchFamily="34" charset="-34"/>
                  <a:cs typeface="Browallia New" pitchFamily="34" charset="-34"/>
                </a:rPr>
                <a:t>100 µm</a:t>
              </a: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CF50920D-B372-42D8-B224-E8C4799E909F}"/>
                </a:ext>
              </a:extLst>
            </p:cNvPr>
            <p:cNvCxnSpPr/>
            <p:nvPr/>
          </p:nvCxnSpPr>
          <p:spPr>
            <a:xfrm>
              <a:off x="6272650" y="6051862"/>
              <a:ext cx="1642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oup 16">
            <a:extLst>
              <a:ext uri="{FF2B5EF4-FFF2-40B4-BE49-F238E27FC236}">
                <a16:creationId xmlns:a16="http://schemas.microsoft.com/office/drawing/2014/main" id="{C918E9B3-4463-41FC-88F4-0D09858A0F18}"/>
              </a:ext>
            </a:extLst>
          </p:cNvPr>
          <p:cNvGrpSpPr>
            <a:grpSpLocks/>
          </p:cNvGrpSpPr>
          <p:nvPr/>
        </p:nvGrpSpPr>
        <p:grpSpPr bwMode="auto">
          <a:xfrm>
            <a:off x="5441351" y="4317169"/>
            <a:ext cx="715963" cy="392113"/>
            <a:chOff x="6021674" y="5791436"/>
            <a:chExt cx="643125" cy="338554"/>
          </a:xfrm>
        </p:grpSpPr>
        <p:sp>
          <p:nvSpPr>
            <p:cNvPr id="22" name="TextBox 26">
              <a:extLst>
                <a:ext uri="{FF2B5EF4-FFF2-40B4-BE49-F238E27FC236}">
                  <a16:creationId xmlns:a16="http://schemas.microsoft.com/office/drawing/2014/main" id="{C74F7736-FFD0-435F-8E65-86177F541A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674" y="5791436"/>
              <a:ext cx="64312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600" b="1">
                  <a:latin typeface="Browallia New" pitchFamily="34" charset="-34"/>
                  <a:cs typeface="Browallia New" pitchFamily="34" charset="-34"/>
                </a:rPr>
                <a:t>100 µm</a:t>
              </a: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255D708B-BD67-4260-967E-E749097DEAD4}"/>
                </a:ext>
              </a:extLst>
            </p:cNvPr>
            <p:cNvCxnSpPr/>
            <p:nvPr/>
          </p:nvCxnSpPr>
          <p:spPr>
            <a:xfrm>
              <a:off x="6272649" y="6051862"/>
              <a:ext cx="1642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 16">
            <a:extLst>
              <a:ext uri="{FF2B5EF4-FFF2-40B4-BE49-F238E27FC236}">
                <a16:creationId xmlns:a16="http://schemas.microsoft.com/office/drawing/2014/main" id="{D94EBE9B-C301-4A33-99FF-4E881B83F25F}"/>
              </a:ext>
            </a:extLst>
          </p:cNvPr>
          <p:cNvGrpSpPr>
            <a:grpSpLocks/>
          </p:cNvGrpSpPr>
          <p:nvPr/>
        </p:nvGrpSpPr>
        <p:grpSpPr bwMode="auto">
          <a:xfrm>
            <a:off x="3449656" y="4317169"/>
            <a:ext cx="715962" cy="392113"/>
            <a:chOff x="6021674" y="5791436"/>
            <a:chExt cx="643125" cy="338554"/>
          </a:xfrm>
        </p:grpSpPr>
        <p:sp>
          <p:nvSpPr>
            <p:cNvPr id="25" name="TextBox 29">
              <a:extLst>
                <a:ext uri="{FF2B5EF4-FFF2-40B4-BE49-F238E27FC236}">
                  <a16:creationId xmlns:a16="http://schemas.microsoft.com/office/drawing/2014/main" id="{4E02B141-B6DC-4CC1-9DC8-1B4A248F28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674" y="5791436"/>
              <a:ext cx="64312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600" b="1" dirty="0">
                  <a:latin typeface="Browallia New" pitchFamily="34" charset="-34"/>
                  <a:cs typeface="Browallia New" pitchFamily="34" charset="-34"/>
                </a:rPr>
                <a:t>100 µm</a:t>
              </a: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095A65E1-7F5B-41CF-BFA2-F35979418800}"/>
                </a:ext>
              </a:extLst>
            </p:cNvPr>
            <p:cNvCxnSpPr/>
            <p:nvPr/>
          </p:nvCxnSpPr>
          <p:spPr>
            <a:xfrm>
              <a:off x="6272650" y="6051862"/>
              <a:ext cx="1642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Group 16">
            <a:extLst>
              <a:ext uri="{FF2B5EF4-FFF2-40B4-BE49-F238E27FC236}">
                <a16:creationId xmlns:a16="http://schemas.microsoft.com/office/drawing/2014/main" id="{EBC7B7D9-DB21-4717-81FE-9C9929C29BC6}"/>
              </a:ext>
            </a:extLst>
          </p:cNvPr>
          <p:cNvGrpSpPr>
            <a:grpSpLocks/>
          </p:cNvGrpSpPr>
          <p:nvPr/>
        </p:nvGrpSpPr>
        <p:grpSpPr bwMode="auto">
          <a:xfrm>
            <a:off x="7461953" y="2678869"/>
            <a:ext cx="715962" cy="392113"/>
            <a:chOff x="6021674" y="5791436"/>
            <a:chExt cx="643125" cy="338554"/>
          </a:xfrm>
        </p:grpSpPr>
        <p:sp>
          <p:nvSpPr>
            <p:cNvPr id="28" name="TextBox 32">
              <a:extLst>
                <a:ext uri="{FF2B5EF4-FFF2-40B4-BE49-F238E27FC236}">
                  <a16:creationId xmlns:a16="http://schemas.microsoft.com/office/drawing/2014/main" id="{65FE1B9A-1218-4544-87A1-A7CF94AF80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674" y="5791436"/>
              <a:ext cx="64312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600" b="1" dirty="0">
                  <a:latin typeface="Browallia New" pitchFamily="34" charset="-34"/>
                  <a:cs typeface="Browallia New" pitchFamily="34" charset="-34"/>
                </a:rPr>
                <a:t>100 µm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390DDA49-124E-4285-BA0E-95617A94C4F7}"/>
                </a:ext>
              </a:extLst>
            </p:cNvPr>
            <p:cNvCxnSpPr/>
            <p:nvPr/>
          </p:nvCxnSpPr>
          <p:spPr>
            <a:xfrm>
              <a:off x="6272650" y="6051862"/>
              <a:ext cx="1642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 16">
            <a:extLst>
              <a:ext uri="{FF2B5EF4-FFF2-40B4-BE49-F238E27FC236}">
                <a16:creationId xmlns:a16="http://schemas.microsoft.com/office/drawing/2014/main" id="{7FFC027C-589D-46EB-96AD-49EEA701AC99}"/>
              </a:ext>
            </a:extLst>
          </p:cNvPr>
          <p:cNvGrpSpPr>
            <a:grpSpLocks/>
          </p:cNvGrpSpPr>
          <p:nvPr/>
        </p:nvGrpSpPr>
        <p:grpSpPr bwMode="auto">
          <a:xfrm>
            <a:off x="5441351" y="2678869"/>
            <a:ext cx="715963" cy="392113"/>
            <a:chOff x="6021674" y="5791436"/>
            <a:chExt cx="643125" cy="338554"/>
          </a:xfrm>
        </p:grpSpPr>
        <p:sp>
          <p:nvSpPr>
            <p:cNvPr id="31" name="TextBox 35">
              <a:extLst>
                <a:ext uri="{FF2B5EF4-FFF2-40B4-BE49-F238E27FC236}">
                  <a16:creationId xmlns:a16="http://schemas.microsoft.com/office/drawing/2014/main" id="{F63BCBC7-BCA6-4252-ACAA-28EC316BAD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674" y="5791436"/>
              <a:ext cx="64312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600" b="1">
                  <a:latin typeface="Browallia New" pitchFamily="34" charset="-34"/>
                  <a:cs typeface="Browallia New" pitchFamily="34" charset="-34"/>
                </a:rPr>
                <a:t>100 µm</a:t>
              </a:r>
            </a:p>
          </p:txBody>
        </p: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04928620-187B-4C3D-B556-F3C2BE83A023}"/>
                </a:ext>
              </a:extLst>
            </p:cNvPr>
            <p:cNvCxnSpPr/>
            <p:nvPr/>
          </p:nvCxnSpPr>
          <p:spPr>
            <a:xfrm>
              <a:off x="6272649" y="6051862"/>
              <a:ext cx="1642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16">
            <a:extLst>
              <a:ext uri="{FF2B5EF4-FFF2-40B4-BE49-F238E27FC236}">
                <a16:creationId xmlns:a16="http://schemas.microsoft.com/office/drawing/2014/main" id="{5F24B55D-E6CF-4D78-85AE-F9516FC43C2D}"/>
              </a:ext>
            </a:extLst>
          </p:cNvPr>
          <p:cNvGrpSpPr>
            <a:grpSpLocks/>
          </p:cNvGrpSpPr>
          <p:nvPr/>
        </p:nvGrpSpPr>
        <p:grpSpPr bwMode="auto">
          <a:xfrm>
            <a:off x="3449656" y="2678869"/>
            <a:ext cx="715962" cy="392113"/>
            <a:chOff x="6021674" y="5791436"/>
            <a:chExt cx="643125" cy="338554"/>
          </a:xfrm>
        </p:grpSpPr>
        <p:sp>
          <p:nvSpPr>
            <p:cNvPr id="34" name="TextBox 38">
              <a:extLst>
                <a:ext uri="{FF2B5EF4-FFF2-40B4-BE49-F238E27FC236}">
                  <a16:creationId xmlns:a16="http://schemas.microsoft.com/office/drawing/2014/main" id="{B108E8B8-DA83-4BD9-883D-EE99A32BD6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674" y="5791436"/>
              <a:ext cx="64312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600" b="1">
                  <a:latin typeface="Browallia New" pitchFamily="34" charset="-34"/>
                  <a:cs typeface="Browallia New" pitchFamily="34" charset="-34"/>
                </a:rPr>
                <a:t>100 µm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E9044BD6-C39E-4A62-B91B-60299D1BEBAF}"/>
                </a:ext>
              </a:extLst>
            </p:cNvPr>
            <p:cNvCxnSpPr/>
            <p:nvPr/>
          </p:nvCxnSpPr>
          <p:spPr>
            <a:xfrm>
              <a:off x="6272650" y="6051862"/>
              <a:ext cx="1642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16">
            <a:extLst>
              <a:ext uri="{FF2B5EF4-FFF2-40B4-BE49-F238E27FC236}">
                <a16:creationId xmlns:a16="http://schemas.microsoft.com/office/drawing/2014/main" id="{459231FE-D83C-4E2A-BF8E-C95EDA3F988C}"/>
              </a:ext>
            </a:extLst>
          </p:cNvPr>
          <p:cNvGrpSpPr>
            <a:grpSpLocks/>
          </p:cNvGrpSpPr>
          <p:nvPr/>
        </p:nvGrpSpPr>
        <p:grpSpPr bwMode="auto">
          <a:xfrm>
            <a:off x="9457440" y="4318757"/>
            <a:ext cx="715963" cy="392112"/>
            <a:chOff x="6021674" y="5791436"/>
            <a:chExt cx="643125" cy="338554"/>
          </a:xfrm>
        </p:grpSpPr>
        <p:sp>
          <p:nvSpPr>
            <p:cNvPr id="37" name="TextBox 41">
              <a:extLst>
                <a:ext uri="{FF2B5EF4-FFF2-40B4-BE49-F238E27FC236}">
                  <a16:creationId xmlns:a16="http://schemas.microsoft.com/office/drawing/2014/main" id="{1E906F5F-43B3-481A-8BD8-AE4CC788A07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674" y="5791436"/>
              <a:ext cx="64312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600" b="1">
                  <a:latin typeface="Browallia New" pitchFamily="34" charset="-34"/>
                  <a:cs typeface="Browallia New" pitchFamily="34" charset="-34"/>
                </a:rPr>
                <a:t>100 µm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941F9845-F660-45F7-A937-E76909775A45}"/>
                </a:ext>
              </a:extLst>
            </p:cNvPr>
            <p:cNvCxnSpPr/>
            <p:nvPr/>
          </p:nvCxnSpPr>
          <p:spPr>
            <a:xfrm>
              <a:off x="6272649" y="6051862"/>
              <a:ext cx="1642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16">
            <a:extLst>
              <a:ext uri="{FF2B5EF4-FFF2-40B4-BE49-F238E27FC236}">
                <a16:creationId xmlns:a16="http://schemas.microsoft.com/office/drawing/2014/main" id="{FBF6539B-5520-45F8-BC66-C8F5304DCF7A}"/>
              </a:ext>
            </a:extLst>
          </p:cNvPr>
          <p:cNvGrpSpPr>
            <a:grpSpLocks/>
          </p:cNvGrpSpPr>
          <p:nvPr/>
        </p:nvGrpSpPr>
        <p:grpSpPr bwMode="auto">
          <a:xfrm>
            <a:off x="9457440" y="2682044"/>
            <a:ext cx="715963" cy="392113"/>
            <a:chOff x="6021674" y="5791436"/>
            <a:chExt cx="643125" cy="338554"/>
          </a:xfrm>
        </p:grpSpPr>
        <p:sp>
          <p:nvSpPr>
            <p:cNvPr id="40" name="TextBox 44">
              <a:extLst>
                <a:ext uri="{FF2B5EF4-FFF2-40B4-BE49-F238E27FC236}">
                  <a16:creationId xmlns:a16="http://schemas.microsoft.com/office/drawing/2014/main" id="{5F4EEA4F-FBDD-4B60-976A-CEDCDBE5235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21674" y="5791436"/>
              <a:ext cx="64312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600" b="1">
                  <a:latin typeface="Browallia New" pitchFamily="34" charset="-34"/>
                  <a:cs typeface="Browallia New" pitchFamily="34" charset="-34"/>
                </a:rPr>
                <a:t>100 µm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9B94A6C5-6CE3-4217-AD4E-88D526654A50}"/>
                </a:ext>
              </a:extLst>
            </p:cNvPr>
            <p:cNvCxnSpPr/>
            <p:nvPr/>
          </p:nvCxnSpPr>
          <p:spPr>
            <a:xfrm>
              <a:off x="6272649" y="6051862"/>
              <a:ext cx="1642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9EACD2A3-4B79-4E8F-8F50-47699A38E9E1}"/>
              </a:ext>
            </a:extLst>
          </p:cNvPr>
          <p:cNvSpPr txBox="1"/>
          <p:nvPr/>
        </p:nvSpPr>
        <p:spPr>
          <a:xfrm>
            <a:off x="1081128" y="3623699"/>
            <a:ext cx="9605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800" b="1" dirty="0"/>
              <a:t>(+)</a:t>
            </a:r>
          </a:p>
          <a:p>
            <a:pPr algn="ctr"/>
            <a:r>
              <a:rPr lang="en-US" sz="1800" b="1" dirty="0"/>
              <a:t>Y-2763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980BFA7-180B-4A30-886A-5BD7F5556F1E}"/>
              </a:ext>
            </a:extLst>
          </p:cNvPr>
          <p:cNvSpPr txBox="1"/>
          <p:nvPr/>
        </p:nvSpPr>
        <p:spPr>
          <a:xfrm>
            <a:off x="1069752" y="1919971"/>
            <a:ext cx="9605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800" b="1" dirty="0"/>
              <a:t>(-)</a:t>
            </a:r>
          </a:p>
          <a:p>
            <a:pPr algn="ctr"/>
            <a:r>
              <a:rPr lang="en-US" sz="1800" b="1" dirty="0"/>
              <a:t>Y-2763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7C7A6C0-4570-4734-9B1F-259227F9A98C}"/>
              </a:ext>
            </a:extLst>
          </p:cNvPr>
          <p:cNvSpPr txBox="1"/>
          <p:nvPr/>
        </p:nvSpPr>
        <p:spPr>
          <a:xfrm>
            <a:off x="8994552" y="4722835"/>
            <a:ext cx="10511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b="1" dirty="0"/>
              <a:t>Day 20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914400" y="5422006"/>
            <a:ext cx="92590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Fig. S1 Growth of </a:t>
            </a:r>
            <a:r>
              <a:rPr lang="en-US" sz="2000" dirty="0" err="1"/>
              <a:t>limbal</a:t>
            </a:r>
            <a:r>
              <a:rPr lang="en-US" sz="2000" dirty="0"/>
              <a:t> stem cells from explants </a:t>
            </a:r>
            <a:r>
              <a:rPr lang="en-US" sz="2000"/>
              <a:t>in CNT-Prime </a:t>
            </a:r>
            <a:r>
              <a:rPr lang="en-US" sz="2000" dirty="0"/>
              <a:t>media with or without a ROCK inhibitor Y-27632</a:t>
            </a:r>
            <a:endParaRPr lang="th-TH" sz="2000" dirty="0"/>
          </a:p>
        </p:txBody>
      </p:sp>
    </p:spTree>
    <p:extLst>
      <p:ext uri="{BB962C8B-B14F-4D97-AF65-F5344CB8AC3E}">
        <p14:creationId xmlns:p14="http://schemas.microsoft.com/office/powerpoint/2010/main" val="12962802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  <p:bldP spid="12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0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Browallia New</vt:lpstr>
      <vt:lpstr>BrowalliaUPC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-VivoBook</dc:creator>
  <cp:lastModifiedBy>Asus-VivoBook</cp:lastModifiedBy>
  <cp:revision>6</cp:revision>
  <dcterms:created xsi:type="dcterms:W3CDTF">2020-02-20T11:43:44Z</dcterms:created>
  <dcterms:modified xsi:type="dcterms:W3CDTF">2020-02-28T11:06:16Z</dcterms:modified>
</cp:coreProperties>
</file>